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irban Maitr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19852"/>
    <a:srgbClr val="E0A9A8"/>
    <a:srgbClr val="DB9B99"/>
    <a:srgbClr val="E1AAA9"/>
    <a:srgbClr val="E8BFBE"/>
    <a:srgbClr val="B9CB8B"/>
    <a:srgbClr val="A8BF6F"/>
    <a:srgbClr val="9EB75F"/>
    <a:srgbClr val="9EBB5F"/>
    <a:srgbClr val="D488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685" autoAdjust="0"/>
  </p:normalViewPr>
  <p:slideViewPr>
    <p:cSldViewPr>
      <p:cViewPr varScale="1">
        <p:scale>
          <a:sx n="123" d="100"/>
          <a:sy n="123" d="100"/>
        </p:scale>
        <p:origin x="4002" y="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998BEA-C3EA-44EF-B610-451E3499E20F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9A11A9-003D-4918-A5E6-6B5D3DD3615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262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47438564"/>
              </p:ext>
            </p:extLst>
          </p:nvPr>
        </p:nvGraphicFramePr>
        <p:xfrm>
          <a:off x="1219200" y="1066800"/>
          <a:ext cx="4699000" cy="56464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02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97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402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877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2880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 smtClean="0">
                          <a:effectLst/>
                        </a:rPr>
                        <a:t>Supplementary</a:t>
                      </a:r>
                      <a:r>
                        <a:rPr lang="en-US" sz="1100" b="1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1100" b="1" u="none" strike="noStrike" dirty="0" smtClean="0">
                          <a:effectLst/>
                        </a:rPr>
                        <a:t>File </a:t>
                      </a:r>
                      <a:r>
                        <a:rPr lang="en-US" sz="1100" b="1" u="none" strike="noStrike" dirty="0">
                          <a:effectLst/>
                        </a:rPr>
                        <a:t>3</a:t>
                      </a:r>
                      <a:r>
                        <a:rPr lang="en-US" sz="1100" u="none" strike="noStrike" dirty="0" smtClean="0">
                          <a:effectLst/>
                        </a:rPr>
                        <a:t>: </a:t>
                      </a:r>
                      <a:r>
                        <a:rPr lang="en-US" sz="1100" u="none" strike="noStrike" dirty="0">
                          <a:effectLst/>
                        </a:rPr>
                        <a:t>Differentially expressed transcripts after CXCR knockdown in CAF cell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Gene</a:t>
                      </a:r>
                      <a:r>
                        <a:rPr lang="en-US" sz="1100" b="1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1100" b="1" u="none" strike="noStrike" dirty="0" smtClean="0">
                          <a:effectLst/>
                        </a:rPr>
                        <a:t>Symb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Access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Mean Fold change (CXCR4 KD-Ctrl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P Va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IL8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00584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1.80728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052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IL33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33439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1.29622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80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</a:rPr>
                        <a:t>TSPAN7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04615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1.197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62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PFKFB3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04566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0.709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65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TNFAIP3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06290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0.70791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6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NLRP3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M_004895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0.5878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74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</a:rPr>
                        <a:t>CD82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2231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786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37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CCL2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2982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18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043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</a:rPr>
                        <a:t>MST4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16542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16259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07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GK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1128127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1383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74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STARD8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1142503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0051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055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NEGR1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173808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150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61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PRTFDC1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20200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17367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12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CPA4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16352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205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00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GPR1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5279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2153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089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KCNK2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1017425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727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43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BIVM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K126520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5803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27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C13orf31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153218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6166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44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ANGPTL2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12098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61820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55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MMP16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5941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2704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087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MIR622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R_030754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343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321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RAB30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14488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344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146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KRT18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0224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702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112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PSG4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02780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716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1123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RHOBTB1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R_024556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8930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474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>
                          <a:effectLst/>
                        </a:rPr>
                        <a:t>PSG2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31246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916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1355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</a:rPr>
                        <a:t>GPRC5B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M_016235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3504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178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84701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658</TotalTime>
  <Words>144</Words>
  <Application>Microsoft Office PowerPoint</Application>
  <PresentationFormat>On-screen Show (4:3)</PresentationFormat>
  <Paragraphs>1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lbert Einstein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ncreatic Cancer</dc:title>
  <dc:creator>Amit Verma</dc:creator>
  <cp:lastModifiedBy>Amit Verma</cp:lastModifiedBy>
  <cp:revision>464</cp:revision>
  <dcterms:created xsi:type="dcterms:W3CDTF">2012-11-01T21:56:30Z</dcterms:created>
  <dcterms:modified xsi:type="dcterms:W3CDTF">2019-10-15T18:55:54Z</dcterms:modified>
</cp:coreProperties>
</file>